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  <p:sldId id="263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1" d="100"/>
          <a:sy n="81" d="100"/>
        </p:scale>
        <p:origin x="2851" y="3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1473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031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0842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8967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301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687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180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3551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393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2820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180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5FBF6-A5B1-48A4-993A-008E8155F569}" type="datetimeFigureOut">
              <a:rPr kumimoji="1" lang="ja-JP" altLang="en-US" smtClean="0"/>
              <a:t>2015/8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63D99-F160-4312-9867-D0A4C7B79E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0966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70532" y="90216"/>
            <a:ext cx="24676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Table 1</a:t>
            </a:r>
            <a:endParaRPr lang="ja-JP" altLang="en-US" b="1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377" y="459548"/>
            <a:ext cx="6546031" cy="17454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1231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>
            <a:off x="138541" y="3541567"/>
            <a:ext cx="656186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600" dirty="0">
                <a:latin typeface="Times New Roman" pitchFamily="18" charset="0"/>
                <a:cs typeface="Times New Roman" pitchFamily="18" charset="0"/>
              </a:rPr>
              <a:t>Stromal vascular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cells </a:t>
            </a:r>
            <a:r>
              <a:rPr lang="en-US" altLang="ja-JP" sz="1600" dirty="0">
                <a:latin typeface="Times New Roman" pitchFamily="18" charset="0"/>
                <a:cs typeface="Times New Roman" pitchFamily="18" charset="0"/>
              </a:rPr>
              <a:t>from mice were gated according to side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scatter</a:t>
            </a:r>
            <a:r>
              <a:rPr lang="ja-JP" altLang="en-U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(SSC) </a:t>
            </a:r>
            <a:r>
              <a:rPr lang="en-US" altLang="ja-JP" sz="1600" dirty="0">
                <a:latin typeface="Times New Roman" pitchFamily="18" charset="0"/>
                <a:cs typeface="Times New Roman" pitchFamily="18" charset="0"/>
              </a:rPr>
              <a:t>and forward scatter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plots (FSC) (R1). Neutrophil</a:t>
            </a:r>
            <a:r>
              <a:rPr lang="ja-JP" altLang="en-US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populations were </a:t>
            </a:r>
            <a:r>
              <a:rPr lang="en-US" altLang="ja-JP" sz="1600" dirty="0">
                <a:latin typeface="Times New Roman" pitchFamily="18" charset="0"/>
                <a:cs typeface="Times New Roman" pitchFamily="18" charset="0"/>
              </a:rPr>
              <a:t>gated according to CD11b and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Ly-6G</a:t>
            </a:r>
            <a:r>
              <a:rPr lang="ja-JP" altLang="en-U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on </a:t>
            </a:r>
            <a:r>
              <a:rPr lang="en-US" altLang="ja-JP" sz="1600" dirty="0">
                <a:latin typeface="Times New Roman" pitchFamily="18" charset="0"/>
                <a:cs typeface="Times New Roman" pitchFamily="18" charset="0"/>
              </a:rPr>
              <a:t>the SSC/FSC </a:t>
            </a:r>
            <a:r>
              <a:rPr lang="en-US" altLang="ja-JP" sz="1600" dirty="0" smtClean="0">
                <a:latin typeface="Times New Roman" pitchFamily="18" charset="0"/>
                <a:cs typeface="Times New Roman" pitchFamily="18" charset="0"/>
              </a:rPr>
              <a:t>plot (R2). </a:t>
            </a:r>
            <a:endParaRPr lang="ja-JP" altLang="ja-JP" sz="16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>
            <a:off x="2295922" y="-3771403"/>
            <a:ext cx="316835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2291730" y="-3824361"/>
            <a:ext cx="316835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>
            <a:off x="2295922" y="-3790453"/>
            <a:ext cx="316835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/>
          <p:cNvSpPr/>
          <p:nvPr/>
        </p:nvSpPr>
        <p:spPr>
          <a:xfrm>
            <a:off x="4077072" y="-3790453"/>
            <a:ext cx="360040" cy="1535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/>
          <p:cNvSpPr/>
          <p:nvPr/>
        </p:nvSpPr>
        <p:spPr>
          <a:xfrm>
            <a:off x="3347467" y="-3824361"/>
            <a:ext cx="144016" cy="1535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/>
          <p:cNvSpPr/>
          <p:nvPr/>
        </p:nvSpPr>
        <p:spPr>
          <a:xfrm flipH="1">
            <a:off x="3798565" y="-3803215"/>
            <a:ext cx="152400" cy="931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/>
          <p:cNvSpPr/>
          <p:nvPr/>
        </p:nvSpPr>
        <p:spPr>
          <a:xfrm flipH="1">
            <a:off x="2564904" y="-3818624"/>
            <a:ext cx="152400" cy="931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 flipH="1">
            <a:off x="3582541" y="-3819028"/>
            <a:ext cx="152400" cy="931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 flipH="1">
            <a:off x="2319164" y="-3789001"/>
            <a:ext cx="63624" cy="55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正方形/長方形 1"/>
          <p:cNvSpPr/>
          <p:nvPr/>
        </p:nvSpPr>
        <p:spPr>
          <a:xfrm>
            <a:off x="3720979" y="1249140"/>
            <a:ext cx="117152" cy="637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2635598" y="1319512"/>
            <a:ext cx="117152" cy="1098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506924" y="2320177"/>
            <a:ext cx="624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1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7553" y="604435"/>
            <a:ext cx="2800253" cy="25604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000000" mc:Ignorable="a14" a14:legacySpreadsheetColorIndex="64"/>
                </a:solidFill>
              </a14:hiddenFill>
            </a:ext>
            <a:ext uri="{91240B29-F687-4F45-9708-019B960494DF}">
              <a14:hiddenLine xmlns:a14="http://schemas.microsoft.com/office/drawing/2010/main" w="1">
                <a:solidFill>
                  <a:srgbClr xmlns:mc="http://schemas.openxmlformats.org/markup-compatibility/2006" val="FFFFFF" mc:Ignorable="a14" a14:legacySpreadsheetColorIndex="65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935469" y="1570141"/>
            <a:ext cx="150272" cy="3270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9" name="正方形/長方形 18"/>
          <p:cNvSpPr/>
          <p:nvPr/>
        </p:nvSpPr>
        <p:spPr>
          <a:xfrm>
            <a:off x="4853933" y="1249140"/>
            <a:ext cx="217400" cy="1619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/>
          <p:cNvSpPr/>
          <p:nvPr/>
        </p:nvSpPr>
        <p:spPr>
          <a:xfrm>
            <a:off x="6035431" y="2408500"/>
            <a:ext cx="217400" cy="1619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831855" y="1570141"/>
            <a:ext cx="624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2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806909" y="3170415"/>
            <a:ext cx="9415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1b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3224498" y="1679007"/>
            <a:ext cx="8822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-6G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9844" y="88798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図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6826" y="604434"/>
            <a:ext cx="2833610" cy="2586263"/>
          </a:xfrm>
          <a:prstGeom prst="rect">
            <a:avLst/>
          </a:prstGeom>
        </p:spPr>
      </p:pic>
      <p:sp>
        <p:nvSpPr>
          <p:cNvPr id="15" name="正方形/長方形 14"/>
          <p:cNvSpPr/>
          <p:nvPr/>
        </p:nvSpPr>
        <p:spPr>
          <a:xfrm>
            <a:off x="2432649" y="1374428"/>
            <a:ext cx="155478" cy="635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252628" y="1201651"/>
            <a:ext cx="624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1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3781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0</TotalTime>
  <Words>51</Words>
  <Application>Microsoft Office PowerPoint</Application>
  <PresentationFormat>画面に合わせる (4:3)</PresentationFormat>
  <Paragraphs>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西範明</dc:creator>
  <cp:lastModifiedBy>川西範明</cp:lastModifiedBy>
  <cp:revision>42</cp:revision>
  <dcterms:created xsi:type="dcterms:W3CDTF">2015-03-20T00:40:16Z</dcterms:created>
  <dcterms:modified xsi:type="dcterms:W3CDTF">2015-08-11T03:53:43Z</dcterms:modified>
</cp:coreProperties>
</file>